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5" d="100"/>
          <a:sy n="85" d="100"/>
        </p:scale>
        <p:origin x="470" y="9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F059E-EDF4-4A1A-879D-CA8C9F1ACE22}" type="datetimeFigureOut">
              <a:rPr lang="it-IT" smtClean="0"/>
              <a:t>17/10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9F299-893F-48E4-ADB0-ADA3783D28E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59156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F059E-EDF4-4A1A-879D-CA8C9F1ACE22}" type="datetimeFigureOut">
              <a:rPr lang="it-IT" smtClean="0"/>
              <a:t>17/10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9F299-893F-48E4-ADB0-ADA3783D28E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035842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F059E-EDF4-4A1A-879D-CA8C9F1ACE22}" type="datetimeFigureOut">
              <a:rPr lang="it-IT" smtClean="0"/>
              <a:t>17/10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9F299-893F-48E4-ADB0-ADA3783D28E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067338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F059E-EDF4-4A1A-879D-CA8C9F1ACE22}" type="datetimeFigureOut">
              <a:rPr lang="it-IT" smtClean="0"/>
              <a:t>17/10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9F299-893F-48E4-ADB0-ADA3783D28E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013486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F059E-EDF4-4A1A-879D-CA8C9F1ACE22}" type="datetimeFigureOut">
              <a:rPr lang="it-IT" smtClean="0"/>
              <a:t>17/10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9F299-893F-48E4-ADB0-ADA3783D28E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986271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F059E-EDF4-4A1A-879D-CA8C9F1ACE22}" type="datetimeFigureOut">
              <a:rPr lang="it-IT" smtClean="0"/>
              <a:t>17/10/202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9F299-893F-48E4-ADB0-ADA3783D28E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979954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F059E-EDF4-4A1A-879D-CA8C9F1ACE22}" type="datetimeFigureOut">
              <a:rPr lang="it-IT" smtClean="0"/>
              <a:t>17/10/2024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9F299-893F-48E4-ADB0-ADA3783D28E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018752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F059E-EDF4-4A1A-879D-CA8C9F1ACE22}" type="datetimeFigureOut">
              <a:rPr lang="it-IT" smtClean="0"/>
              <a:t>17/10/2024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9F299-893F-48E4-ADB0-ADA3783D28E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944979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F059E-EDF4-4A1A-879D-CA8C9F1ACE22}" type="datetimeFigureOut">
              <a:rPr lang="it-IT" smtClean="0"/>
              <a:t>17/10/2024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9F299-893F-48E4-ADB0-ADA3783D28E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664196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F059E-EDF4-4A1A-879D-CA8C9F1ACE22}" type="datetimeFigureOut">
              <a:rPr lang="it-IT" smtClean="0"/>
              <a:t>17/10/202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9F299-893F-48E4-ADB0-ADA3783D28E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925922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F059E-EDF4-4A1A-879D-CA8C9F1ACE22}" type="datetimeFigureOut">
              <a:rPr lang="it-IT" smtClean="0"/>
              <a:t>17/10/202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9F299-893F-48E4-ADB0-ADA3783D28E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485848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7F059E-EDF4-4A1A-879D-CA8C9F1ACE22}" type="datetimeFigureOut">
              <a:rPr lang="it-IT" smtClean="0"/>
              <a:t>17/10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49F299-893F-48E4-ADB0-ADA3783D28E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544366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92397" y="702000"/>
            <a:ext cx="8769543" cy="6156000"/>
          </a:xfrm>
          <a:prstGeom prst="rect">
            <a:avLst/>
          </a:prstGeom>
        </p:spPr>
      </p:pic>
      <p:sp>
        <p:nvSpPr>
          <p:cNvPr id="2" name="CasellaDiTesto 1"/>
          <p:cNvSpPr txBox="1"/>
          <p:nvPr/>
        </p:nvSpPr>
        <p:spPr>
          <a:xfrm>
            <a:off x="298174" y="69574"/>
            <a:ext cx="117579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it-IT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formation – </a:t>
            </a:r>
            <a:r>
              <a:rPr lang="it-IT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it-IT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. 1</a:t>
            </a:r>
            <a:r>
              <a:rPr lang="it-IT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it-IT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it-IT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ycemic</a:t>
            </a:r>
            <a:r>
              <a:rPr lang="it-IT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rics</a:t>
            </a:r>
            <a:r>
              <a:rPr lang="it-IT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cording</a:t>
            </a:r>
            <a:r>
              <a:rPr lang="it-IT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o </a:t>
            </a:r>
            <a:r>
              <a:rPr lang="it-IT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going</a:t>
            </a:r>
            <a:r>
              <a:rPr lang="it-IT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eroid</a:t>
            </a:r>
            <a:r>
              <a:rPr lang="it-IT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rapy</a:t>
            </a:r>
            <a:r>
              <a:rPr lang="it-IT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uring</a:t>
            </a:r>
            <a:r>
              <a:rPr lang="it-IT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ospitalization</a:t>
            </a:r>
            <a:r>
              <a:rPr lang="it-IT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it-IT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CasellaDiTesto 2"/>
          <p:cNvSpPr txBox="1"/>
          <p:nvPr/>
        </p:nvSpPr>
        <p:spPr>
          <a:xfrm>
            <a:off x="1954306" y="6381975"/>
            <a:ext cx="3316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0928629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18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Company>Ospedale San Raffael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Caretto Amelia</dc:creator>
  <cp:lastModifiedBy>Caretto Amelia</cp:lastModifiedBy>
  <cp:revision>5</cp:revision>
  <dcterms:created xsi:type="dcterms:W3CDTF">2024-04-13T22:19:15Z</dcterms:created>
  <dcterms:modified xsi:type="dcterms:W3CDTF">2024-10-17T21:04:35Z</dcterms:modified>
</cp:coreProperties>
</file>